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35" autoAdjust="0"/>
  </p:normalViewPr>
  <p:slideViewPr>
    <p:cSldViewPr snapToGrid="0" snapToObjects="1">
      <p:cViewPr varScale="1">
        <p:scale>
          <a:sx n="128" d="100"/>
          <a:sy n="128" d="100"/>
        </p:scale>
        <p:origin x="1704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6196B-2051-4D40-AC4C-72C72D635284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8711-3657-0841-A083-E62E8F97F2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730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6196B-2051-4D40-AC4C-72C72D635284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8711-3657-0841-A083-E62E8F97F2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996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6196B-2051-4D40-AC4C-72C72D635284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8711-3657-0841-A083-E62E8F97F2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172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6196B-2051-4D40-AC4C-72C72D635284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8711-3657-0841-A083-E62E8F97F2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56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6196B-2051-4D40-AC4C-72C72D635284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8711-3657-0841-A083-E62E8F97F2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956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6196B-2051-4D40-AC4C-72C72D635284}" type="datetimeFigureOut">
              <a:rPr lang="en-US" smtClean="0"/>
              <a:t>10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8711-3657-0841-A083-E62E8F97F2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329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6196B-2051-4D40-AC4C-72C72D635284}" type="datetimeFigureOut">
              <a:rPr lang="en-US" smtClean="0"/>
              <a:t>10/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8711-3657-0841-A083-E62E8F97F2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187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6196B-2051-4D40-AC4C-72C72D635284}" type="datetimeFigureOut">
              <a:rPr lang="en-US" smtClean="0"/>
              <a:t>10/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8711-3657-0841-A083-E62E8F97F2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7382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6196B-2051-4D40-AC4C-72C72D635284}" type="datetimeFigureOut">
              <a:rPr lang="en-US" smtClean="0"/>
              <a:t>10/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8711-3657-0841-A083-E62E8F97F2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209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6196B-2051-4D40-AC4C-72C72D635284}" type="datetimeFigureOut">
              <a:rPr lang="en-US" smtClean="0"/>
              <a:t>10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8711-3657-0841-A083-E62E8F97F2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077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6196B-2051-4D40-AC4C-72C72D635284}" type="datetimeFigureOut">
              <a:rPr lang="en-US" smtClean="0"/>
              <a:t>10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38711-3657-0841-A083-E62E8F97F2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113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96196B-2051-4D40-AC4C-72C72D635284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C38711-3657-0841-A083-E62E8F97F2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7215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Ομάδα 1">
            <a:extLst>
              <a:ext uri="{FF2B5EF4-FFF2-40B4-BE49-F238E27FC236}">
                <a16:creationId xmlns:a16="http://schemas.microsoft.com/office/drawing/2014/main" id="{51759BAD-C8E7-4A81-80C6-D436D9799723}"/>
              </a:ext>
            </a:extLst>
          </p:cNvPr>
          <p:cNvGrpSpPr/>
          <p:nvPr/>
        </p:nvGrpSpPr>
        <p:grpSpPr>
          <a:xfrm>
            <a:off x="274429" y="451499"/>
            <a:ext cx="8762482" cy="5628900"/>
            <a:chOff x="332095" y="451499"/>
            <a:chExt cx="8762482" cy="5628900"/>
          </a:xfrm>
        </p:grpSpPr>
        <p:sp>
          <p:nvSpPr>
            <p:cNvPr id="4" name="TextBox 3"/>
            <p:cNvSpPr txBox="1"/>
            <p:nvPr/>
          </p:nvSpPr>
          <p:spPr>
            <a:xfrm rot="16200000">
              <a:off x="-694740" y="1478336"/>
              <a:ext cx="2700001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/>
                  <a:cs typeface="Arial"/>
                </a:rPr>
                <a:t>Soluble solid concentration (</a:t>
              </a:r>
              <a:r>
                <a:rPr lang="el-GR" b="1" dirty="0">
                  <a:latin typeface="Arial"/>
                  <a:cs typeface="Arial"/>
                </a:rPr>
                <a:t>%</a:t>
              </a:r>
              <a:r>
                <a:rPr lang="en-US" b="1" dirty="0"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 rot="16200000">
              <a:off x="2729472" y="1478333"/>
              <a:ext cx="269999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/>
                  <a:cs typeface="Arial"/>
                </a:rPr>
                <a:t>Titratable acidity (malic acid, </a:t>
              </a:r>
              <a:r>
                <a:rPr lang="el-GR" b="1" dirty="0">
                  <a:latin typeface="Arial"/>
                  <a:cs typeface="Arial"/>
                </a:rPr>
                <a:t>%</a:t>
              </a:r>
              <a:r>
                <a:rPr lang="en-US" b="1" dirty="0">
                  <a:latin typeface="Arial"/>
                  <a:cs typeface="Arial"/>
                </a:rPr>
                <a:t>)</a:t>
              </a:r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34870" y="451499"/>
              <a:ext cx="2534694" cy="2700001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74011" y="451499"/>
              <a:ext cx="2513750" cy="270000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2899791" y="606600"/>
              <a:ext cx="77555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>
                  <a:latin typeface="Arial"/>
                  <a:cs typeface="Arial"/>
                </a:rPr>
                <a:t>(A)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317138" y="606600"/>
              <a:ext cx="77555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>
                  <a:latin typeface="Arial"/>
                  <a:cs typeface="Arial"/>
                </a:rPr>
                <a:t>(B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-596921" y="4534576"/>
              <a:ext cx="267769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/>
                  <a:cs typeface="Arial"/>
                </a:rPr>
                <a:t>Firmness </a:t>
              </a:r>
              <a:r>
                <a:rPr lang="el-GR" b="1" dirty="0">
                  <a:latin typeface="Arial"/>
                  <a:cs typeface="Arial"/>
                </a:rPr>
                <a:t>(</a:t>
              </a:r>
              <a:r>
                <a:rPr lang="en-US" b="1" dirty="0">
                  <a:latin typeface="Arial"/>
                  <a:cs typeface="Arial"/>
                </a:rPr>
                <a:t>kg)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2677634" y="4407232"/>
              <a:ext cx="270000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/>
                  <a:cs typeface="Arial"/>
                </a:rPr>
                <a:t>Respiration rate</a:t>
              </a:r>
            </a:p>
            <a:p>
              <a:pPr algn="ctr"/>
              <a:r>
                <a:rPr lang="en-US" b="1" dirty="0">
                  <a:latin typeface="Arial"/>
                  <a:cs typeface="Arial"/>
                </a:rPr>
                <a:t>(mL kg</a:t>
              </a:r>
              <a:r>
                <a:rPr lang="en-US" b="1" baseline="30000" dirty="0">
                  <a:latin typeface="Arial"/>
                  <a:cs typeface="Arial"/>
                </a:rPr>
                <a:t>-1</a:t>
              </a:r>
              <a:r>
                <a:rPr lang="en-US" b="1" dirty="0">
                  <a:latin typeface="Arial"/>
                  <a:cs typeface="Arial"/>
                </a:rPr>
                <a:t> h</a:t>
              </a:r>
              <a:r>
                <a:rPr lang="en-US" b="1" baseline="30000" dirty="0">
                  <a:latin typeface="Arial"/>
                  <a:cs typeface="Arial"/>
                </a:rPr>
                <a:t>-1</a:t>
              </a:r>
              <a:r>
                <a:rPr lang="en-US" b="1" dirty="0">
                  <a:latin typeface="Arial"/>
                  <a:cs typeface="Arial"/>
                </a:rPr>
                <a:t>)</a:t>
              </a:r>
            </a:p>
          </p:txBody>
        </p:sp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83033" y="3380397"/>
              <a:ext cx="2534695" cy="2700001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422175" y="3380396"/>
              <a:ext cx="2513750" cy="2677691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040858" y="704281"/>
              <a:ext cx="2053719" cy="1275796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2847955" y="3529890"/>
              <a:ext cx="77555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>
                  <a:latin typeface="Arial"/>
                  <a:cs typeface="Arial"/>
                </a:rPr>
                <a:t>(C)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265302" y="3529890"/>
              <a:ext cx="77555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>
                  <a:latin typeface="Arial"/>
                  <a:cs typeface="Arial"/>
                </a:rPr>
                <a:t>(D)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EF031E48-EE57-8A4B-9D85-BC7DBE19277E}"/>
              </a:ext>
            </a:extLst>
          </p:cNvPr>
          <p:cNvSpPr txBox="1"/>
          <p:nvPr/>
        </p:nvSpPr>
        <p:spPr>
          <a:xfrm>
            <a:off x="449758" y="6282407"/>
            <a:ext cx="8425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ipening parameters in apple fruit challenged with 1-MCP and O</a:t>
            </a:r>
            <a:r>
              <a:rPr lang="en-US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l-G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0177126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51</Words>
  <Application>Microsoft Macintosh PowerPoint</Application>
  <PresentationFormat>Προβολή στην οθόνη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2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Παρουσίαση του PowerPoint</vt:lpstr>
    </vt:vector>
  </TitlesOfParts>
  <Company>EK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vangelos Karagiannis</dc:creator>
  <cp:lastModifiedBy>Athanasios Molasiotis</cp:lastModifiedBy>
  <cp:revision>17</cp:revision>
  <dcterms:created xsi:type="dcterms:W3CDTF">2017-01-18T08:33:11Z</dcterms:created>
  <dcterms:modified xsi:type="dcterms:W3CDTF">2019-10-01T12:51:38Z</dcterms:modified>
</cp:coreProperties>
</file>